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68769-AFC1-40DA-8606-A94B3CE06D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EEC1C-6A19-4A22-83AF-6BC70C75A1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A6E93-4E8B-4005-8DF3-7D073228CD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5A55F-7EA9-4DDE-A8B4-4263CAB415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4FCF7-BD0D-4A13-8E4E-FB52D11B55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FE048-6D0A-4DEB-AE8E-35B5774621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FD0F8-CB0A-4941-A0F4-EED2DBE87E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42867-34B7-43AF-B44F-37FF248299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4DBB4-0342-423C-B8E8-C39928CA5F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D57FD-EF91-4217-AEFB-3DFCFDA7C4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79948-0F92-4900-9FAA-C5120EE97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17EF5-E7D0-47DD-A6DF-2F0E2CECC0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E7287D-F94A-41EE-9A32-AEF4B66A642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28600" y="1591200"/>
            <a:ext cx="64641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CCTGTCCCCACTAACCCTCTCTGCCAATGTGTTTTCTAGATTCCCAACTTCTTCTGGAGCCTGGGGATCGGTCACACTG</a:t>
            </a:r>
            <a:r>
              <a:rPr b="0" lang="en-US" sz="1000" spc="-1" strike="noStrike">
                <a:solidFill>
                  <a:srgbClr val="0070c0"/>
                </a:solidFill>
                <a:latin typeface="Arial Unicode MS"/>
                <a:ea typeface="Arial"/>
              </a:rPr>
              <a:t>GT</a:t>
            </a:r>
            <a:r>
              <a:rPr b="0" lang="en-US" sz="1000" spc="-1" strike="noStrike">
                <a:solidFill>
                  <a:srgbClr val="ff0000"/>
                </a:solidFill>
                <a:latin typeface="Arial Unicode MS"/>
                <a:ea typeface="Arial"/>
              </a:rPr>
              <a:t>GCGTGGTGGCATACTGGGAGGAGAAGACGAGAGTGGGGAGGCTCTACTGTGTCCAGGAGCCCTCTCTGGATATCTTCTATGATCTACCTC</a:t>
            </a:r>
            <a:r>
              <a:rPr b="0" lang="en-US" sz="1000" spc="-1" strike="noStrike">
                <a:solidFill>
                  <a:srgbClr val="0070c0"/>
                </a:solidFill>
                <a:latin typeface="Arial Unicode MS"/>
                <a:ea typeface="Arial"/>
              </a:rPr>
              <a:t>AG</a:t>
            </a: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GGGAATGGCTTTTGCCTCGGACAGCTC AATTCGGACAACAAGAGTCAGCTGGT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1727280" y="404640"/>
            <a:ext cx="346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art of the human SMAD7 Exon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291960" y="2743200"/>
            <a:ext cx="5940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 algn="just">
              <a:tabLst>
                <a:tab algn="l" pos="0"/>
                <a:tab algn="l" pos="1744560"/>
                <a:tab algn="l" pos="232740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LLLEPGDRSH    W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VVAYWEEK   TRVGRLYCVQ    EPSLDIFYDL      PQ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GNGFCLGQ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 algn="just">
              <a:tabLst>
                <a:tab algn="l" pos="0"/>
                <a:tab algn="l" pos="1744560"/>
                <a:tab algn="l" pos="232740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             </a:t>
            </a:r>
            <a:r>
              <a:rPr b="1" lang="en-US" sz="1200" spc="-1" strike="noStrike">
                <a:solidFill>
                  <a:srgbClr val="ff0000"/>
                </a:solidFill>
                <a:latin typeface="Calibri"/>
                <a:ea typeface="Arial"/>
              </a:rPr>
              <a:t>WGMAFASDSS IRTTRVSWYR KCGARSAVAS S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 algn="just">
              <a:tabLst>
                <a:tab algn="l" pos="0"/>
                <a:tab algn="l" pos="1744560"/>
                <a:tab algn="l" pos="232740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LNSDNKSQLV   QKVRSKIGCG   IQLTREVDGV      WVYNRSSYPI    FIKSATLDNP      DSRTLLVHKV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47600" y="4267080"/>
            <a:ext cx="662616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Human SMAD7∆ and mouse Smad7∆ are conserved. (A) Nucleotide sequence spanning the alternative splice site of the human SMAD7 gene. Blue nucleotides are splicing sites. Red and blue nucleotides are skipped in SMAD7∆. (B) Protein sequence spanning the alternative splice site of human Smad7 gene. Black amino acids are in SMAD7 while red amino acids are in SMAD7∆. *, stop codon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"/>
          <p:cNvSpPr/>
          <p:nvPr/>
        </p:nvSpPr>
        <p:spPr>
          <a:xfrm>
            <a:off x="5848200" y="15228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227160" y="990720"/>
            <a:ext cx="41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237960" y="2373480"/>
            <a:ext cx="41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15T20:25:31Z</dcterms:created>
  <dc:creator>Shukla, Anjali (NIH/NCI) [E]</dc:creator>
  <dc:description/>
  <dc:language>en-US</dc:language>
  <cp:lastModifiedBy>Shukla, Anjali (NIH/NCI) [E]</cp:lastModifiedBy>
  <dcterms:modified xsi:type="dcterms:W3CDTF">2016-08-09T18:34:46Z</dcterms:modified>
  <cp:revision>2</cp:revision>
  <dc:subject/>
  <dc:title>PowerPoint Presentation</dc:title>
</cp:coreProperties>
</file>